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3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88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785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35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75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68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366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51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4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1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6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E77EF947-A006-47FB-BF93-CB5456838061}"/>
              </a:ext>
            </a:extLst>
          </p:cNvPr>
          <p:cNvGrpSpPr/>
          <p:nvPr/>
        </p:nvGrpSpPr>
        <p:grpSpPr>
          <a:xfrm>
            <a:off x="144384" y="1106294"/>
            <a:ext cx="6411882" cy="4306524"/>
            <a:chOff x="144384" y="1106294"/>
            <a:chExt cx="6411882" cy="4306524"/>
          </a:xfrm>
        </p:grpSpPr>
        <p:pic>
          <p:nvPicPr>
            <p:cNvPr id="53" name="Image 52">
              <a:extLst>
                <a:ext uri="{FF2B5EF4-FFF2-40B4-BE49-F238E27FC236}">
                  <a16:creationId xmlns:a16="http://schemas.microsoft.com/office/drawing/2014/main" id="{18F1AF70-B890-4B4B-A519-3647FFB4A7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4384" y="1106294"/>
              <a:ext cx="6411882" cy="3465706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B066D15C-B620-4433-907C-E960D346A2E6}"/>
                </a:ext>
              </a:extLst>
            </p:cNvPr>
            <p:cNvSpPr/>
            <p:nvPr/>
          </p:nvSpPr>
          <p:spPr>
            <a:xfrm>
              <a:off x="360008" y="5012708"/>
              <a:ext cx="619625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GB" sz="1000" b="1" dirty="0"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S2: </a:t>
              </a:r>
              <a:r>
                <a:rPr lang="en-GB" sz="1000" dirty="0"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HRII immunostaining in a panel of PDX models evaluated by GHs scoring. For each pathology, number of PDX tested, mean value and range of AMHRII global score are specified.</a:t>
              </a:r>
              <a:endParaRPr lang="fr-FR" sz="1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169943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B515BEF039449DE3BC99362D278E" ma:contentTypeVersion="10" ma:contentTypeDescription="Crée un document." ma:contentTypeScope="" ma:versionID="c010b241486ab1b742d6b1cfd92bd9ca">
  <xsd:schema xmlns:xsd="http://www.w3.org/2001/XMLSchema" xmlns:xs="http://www.w3.org/2001/XMLSchema" xmlns:p="http://schemas.microsoft.com/office/2006/metadata/properties" xmlns:ns3="2157c777-3de9-4437-aa98-f40188f9bc26" targetNamespace="http://schemas.microsoft.com/office/2006/metadata/properties" ma:root="true" ma:fieldsID="9b3ffa30733a75f543c304a10f791494" ns3:_="">
    <xsd:import namespace="2157c777-3de9-4437-aa98-f40188f9bc2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7c777-3de9-4437-aa98-f40188f9bc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43B1352-F438-4490-A2FA-EADDA78BA03C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BDDE9BC7-046D-4CBE-B094-78B2705804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1A7F6E9-6386-46A3-86A7-A3A282E14C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157c777-3de9-4437-aa98-f40188f9bc2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Format US (216 x 279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 Barret</dc:creator>
  <cp:lastModifiedBy>JM Barret</cp:lastModifiedBy>
  <cp:revision>15</cp:revision>
  <dcterms:created xsi:type="dcterms:W3CDTF">2020-04-02T09:48:46Z</dcterms:created>
  <dcterms:modified xsi:type="dcterms:W3CDTF">2021-04-01T07:15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B515BEF039449DE3BC99362D278E</vt:lpwstr>
  </property>
</Properties>
</file>